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13716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4"/>
  </p:normalViewPr>
  <p:slideViewPr>
    <p:cSldViewPr snapToGrid="0">
      <p:cViewPr varScale="1">
        <p:scale>
          <a:sx n="96" d="100"/>
          <a:sy n="96" d="100"/>
        </p:scale>
        <p:origin x="269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rei Wu" userId="935b1b74ff2f2987" providerId="LiveId" clId="{1854D986-F87E-40F0-A096-6F3B6D2CC249}"/>
    <pc:docChg chg="undo custSel addSld modSld">
      <pc:chgData name="Derei Wu" userId="935b1b74ff2f2987" providerId="LiveId" clId="{1854D986-F87E-40F0-A096-6F3B6D2CC249}" dt="2021-08-16T12:13:53.721" v="69" actId="113"/>
      <pc:docMkLst>
        <pc:docMk/>
      </pc:docMkLst>
      <pc:sldChg chg="addSp modSp mod">
        <pc:chgData name="Derei Wu" userId="935b1b74ff2f2987" providerId="LiveId" clId="{1854D986-F87E-40F0-A096-6F3B6D2CC249}" dt="2021-08-16T12:09:03.607" v="47" actId="1076"/>
        <pc:sldMkLst>
          <pc:docMk/>
          <pc:sldMk cId="799743445" sldId="256"/>
        </pc:sldMkLst>
        <pc:spChg chg="mod">
          <ac:chgData name="Derei Wu" userId="935b1b74ff2f2987" providerId="LiveId" clId="{1854D986-F87E-40F0-A096-6F3B6D2CC249}" dt="2021-08-16T12:08:41.492" v="28" actId="1036"/>
          <ac:spMkLst>
            <pc:docMk/>
            <pc:sldMk cId="799743445" sldId="256"/>
            <ac:spMk id="6" creationId="{AA209B12-63A1-46C4-8C5B-76F02F84E309}"/>
          </ac:spMkLst>
        </pc:spChg>
        <pc:spChg chg="add mod">
          <ac:chgData name="Derei Wu" userId="935b1b74ff2f2987" providerId="LiveId" clId="{1854D986-F87E-40F0-A096-6F3B6D2CC249}" dt="2021-08-16T12:09:03.607" v="47" actId="1076"/>
          <ac:spMkLst>
            <pc:docMk/>
            <pc:sldMk cId="799743445" sldId="256"/>
            <ac:spMk id="7" creationId="{92D3DDD0-91FB-4725-BA48-AD18FA278332}"/>
          </ac:spMkLst>
        </pc:spChg>
        <pc:graphicFrameChg chg="mod">
          <ac:chgData name="Derei Wu" userId="935b1b74ff2f2987" providerId="LiveId" clId="{1854D986-F87E-40F0-A096-6F3B6D2CC249}" dt="2021-08-16T12:08:41.492" v="28" actId="1036"/>
          <ac:graphicFrameMkLst>
            <pc:docMk/>
            <pc:sldMk cId="799743445" sldId="256"/>
            <ac:graphicFrameMk id="2" creationId="{54E531A8-7362-4217-AF5D-3D219B62B713}"/>
          </ac:graphicFrameMkLst>
        </pc:graphicFrameChg>
        <pc:graphicFrameChg chg="mod">
          <ac:chgData name="Derei Wu" userId="935b1b74ff2f2987" providerId="LiveId" clId="{1854D986-F87E-40F0-A096-6F3B6D2CC249}" dt="2021-08-16T12:08:41.492" v="28" actId="1036"/>
          <ac:graphicFrameMkLst>
            <pc:docMk/>
            <pc:sldMk cId="799743445" sldId="256"/>
            <ac:graphicFrameMk id="3" creationId="{DC5639D3-BC4D-4D43-A0E6-E76F1D0A0238}"/>
          </ac:graphicFrameMkLst>
        </pc:graphicFrameChg>
        <pc:graphicFrameChg chg="mod">
          <ac:chgData name="Derei Wu" userId="935b1b74ff2f2987" providerId="LiveId" clId="{1854D986-F87E-40F0-A096-6F3B6D2CC249}" dt="2021-08-16T12:08:41.492" v="28" actId="1036"/>
          <ac:graphicFrameMkLst>
            <pc:docMk/>
            <pc:sldMk cId="799743445" sldId="256"/>
            <ac:graphicFrameMk id="4" creationId="{921EF72C-A428-44BB-855E-0734D63BFF0B}"/>
          </ac:graphicFrameMkLst>
        </pc:graphicFrameChg>
        <pc:graphicFrameChg chg="mod">
          <ac:chgData name="Derei Wu" userId="935b1b74ff2f2987" providerId="LiveId" clId="{1854D986-F87E-40F0-A096-6F3B6D2CC249}" dt="2021-08-16T12:08:41.492" v="28" actId="1036"/>
          <ac:graphicFrameMkLst>
            <pc:docMk/>
            <pc:sldMk cId="799743445" sldId="256"/>
            <ac:graphicFrameMk id="5" creationId="{E45C4B84-6D4A-4E5A-8486-88D494959046}"/>
          </ac:graphicFrameMkLst>
        </pc:graphicFrameChg>
      </pc:sldChg>
      <pc:sldChg chg="addSp modSp new mod">
        <pc:chgData name="Derei Wu" userId="935b1b74ff2f2987" providerId="LiveId" clId="{1854D986-F87E-40F0-A096-6F3B6D2CC249}" dt="2021-08-16T12:13:53.721" v="69" actId="113"/>
        <pc:sldMkLst>
          <pc:docMk/>
          <pc:sldMk cId="674739061" sldId="257"/>
        </pc:sldMkLst>
        <pc:spChg chg="add mod">
          <ac:chgData name="Derei Wu" userId="935b1b74ff2f2987" providerId="LiveId" clId="{1854D986-F87E-40F0-A096-6F3B6D2CC249}" dt="2021-08-16T12:09:13.758" v="50" actId="20577"/>
          <ac:spMkLst>
            <pc:docMk/>
            <pc:sldMk cId="674739061" sldId="257"/>
            <ac:spMk id="2" creationId="{284F7B0A-5B13-473C-A9A4-FBF27C1858B6}"/>
          </ac:spMkLst>
        </pc:spChg>
        <pc:spChg chg="mod">
          <ac:chgData name="Derei Wu" userId="935b1b74ff2f2987" providerId="LiveId" clId="{1854D986-F87E-40F0-A096-6F3B6D2CC249}" dt="2021-08-16T12:09:35.357" v="51"/>
          <ac:spMkLst>
            <pc:docMk/>
            <pc:sldMk cId="674739061" sldId="257"/>
            <ac:spMk id="7" creationId="{EFE1A6CD-AC37-4E8E-8B6B-8089C286C0CB}"/>
          </ac:spMkLst>
        </pc:spChg>
        <pc:spChg chg="mod">
          <ac:chgData name="Derei Wu" userId="935b1b74ff2f2987" providerId="LiveId" clId="{1854D986-F87E-40F0-A096-6F3B6D2CC249}" dt="2021-08-16T12:09:35.357" v="51"/>
          <ac:spMkLst>
            <pc:docMk/>
            <pc:sldMk cId="674739061" sldId="257"/>
            <ac:spMk id="8" creationId="{414FB12F-5EAA-4A30-8F60-60500904506C}"/>
          </ac:spMkLst>
        </pc:spChg>
        <pc:spChg chg="mod">
          <ac:chgData name="Derei Wu" userId="935b1b74ff2f2987" providerId="LiveId" clId="{1854D986-F87E-40F0-A096-6F3B6D2CC249}" dt="2021-08-16T12:09:35.357" v="51"/>
          <ac:spMkLst>
            <pc:docMk/>
            <pc:sldMk cId="674739061" sldId="257"/>
            <ac:spMk id="10" creationId="{8BA492B9-9661-4747-8163-B5013DC29AD5}"/>
          </ac:spMkLst>
        </pc:spChg>
        <pc:spChg chg="mod">
          <ac:chgData name="Derei Wu" userId="935b1b74ff2f2987" providerId="LiveId" clId="{1854D986-F87E-40F0-A096-6F3B6D2CC249}" dt="2021-08-16T12:09:35.357" v="51"/>
          <ac:spMkLst>
            <pc:docMk/>
            <pc:sldMk cId="674739061" sldId="257"/>
            <ac:spMk id="14" creationId="{CEF0DC3C-A642-4C1B-9011-2338B9107673}"/>
          </ac:spMkLst>
        </pc:spChg>
        <pc:grpChg chg="add mod">
          <ac:chgData name="Derei Wu" userId="935b1b74ff2f2987" providerId="LiveId" clId="{1854D986-F87E-40F0-A096-6F3B6D2CC249}" dt="2021-08-16T12:13:13.124" v="59" actId="1076"/>
          <ac:grpSpMkLst>
            <pc:docMk/>
            <pc:sldMk cId="674739061" sldId="257"/>
            <ac:grpSpMk id="3" creationId="{4B0E5D08-9508-472D-849D-513A9DE39882}"/>
          </ac:grpSpMkLst>
        </pc:grpChg>
        <pc:grpChg chg="mod">
          <ac:chgData name="Derei Wu" userId="935b1b74ff2f2987" providerId="LiveId" clId="{1854D986-F87E-40F0-A096-6F3B6D2CC249}" dt="2021-08-16T12:09:35.357" v="51"/>
          <ac:grpSpMkLst>
            <pc:docMk/>
            <pc:sldMk cId="674739061" sldId="257"/>
            <ac:grpSpMk id="4" creationId="{2D35CF4B-8D1C-4293-8954-3F44F1E62B86}"/>
          </ac:grpSpMkLst>
        </pc:grpChg>
        <pc:grpChg chg="mod">
          <ac:chgData name="Derei Wu" userId="935b1b74ff2f2987" providerId="LiveId" clId="{1854D986-F87E-40F0-A096-6F3B6D2CC249}" dt="2021-08-16T12:09:35.357" v="51"/>
          <ac:grpSpMkLst>
            <pc:docMk/>
            <pc:sldMk cId="674739061" sldId="257"/>
            <ac:grpSpMk id="9" creationId="{6C27F798-64B2-446D-871F-ACAF9A5F5079}"/>
          </ac:grpSpMkLst>
        </pc:grpChg>
        <pc:grpChg chg="mod">
          <ac:chgData name="Derei Wu" userId="935b1b74ff2f2987" providerId="LiveId" clId="{1854D986-F87E-40F0-A096-6F3B6D2CC249}" dt="2021-08-16T12:09:35.357" v="51"/>
          <ac:grpSpMkLst>
            <pc:docMk/>
            <pc:sldMk cId="674739061" sldId="257"/>
            <ac:grpSpMk id="11" creationId="{D5A226A3-3061-41BA-B673-10A88C32CF53}"/>
          </ac:grpSpMkLst>
        </pc:grpChg>
        <pc:graphicFrameChg chg="add mod modGraphic">
          <ac:chgData name="Derei Wu" userId="935b1b74ff2f2987" providerId="LiveId" clId="{1854D986-F87E-40F0-A096-6F3B6D2CC249}" dt="2021-08-16T12:13:53.721" v="69" actId="113"/>
          <ac:graphicFrameMkLst>
            <pc:docMk/>
            <pc:sldMk cId="674739061" sldId="257"/>
            <ac:graphicFrameMk id="15" creationId="{0F322639-1430-4C86-8232-A3B2E76C8E15}"/>
          </ac:graphicFrameMkLst>
        </pc:graphicFrameChg>
        <pc:picChg chg="mod">
          <ac:chgData name="Derei Wu" userId="935b1b74ff2f2987" providerId="LiveId" clId="{1854D986-F87E-40F0-A096-6F3B6D2CC249}" dt="2021-08-16T12:09:35.357" v="51"/>
          <ac:picMkLst>
            <pc:docMk/>
            <pc:sldMk cId="674739061" sldId="257"/>
            <ac:picMk id="5" creationId="{535D92E2-F139-4115-82BA-DF814A3BF13D}"/>
          </ac:picMkLst>
        </pc:picChg>
        <pc:picChg chg="mod">
          <ac:chgData name="Derei Wu" userId="935b1b74ff2f2987" providerId="LiveId" clId="{1854D986-F87E-40F0-A096-6F3B6D2CC249}" dt="2021-08-16T12:09:35.357" v="51"/>
          <ac:picMkLst>
            <pc:docMk/>
            <pc:sldMk cId="674739061" sldId="257"/>
            <ac:picMk id="6" creationId="{9595D81C-536E-4217-AF04-30898D493358}"/>
          </ac:picMkLst>
        </pc:picChg>
        <pc:cxnChg chg="mod">
          <ac:chgData name="Derei Wu" userId="935b1b74ff2f2987" providerId="LiveId" clId="{1854D986-F87E-40F0-A096-6F3B6D2CC249}" dt="2021-08-16T12:09:35.357" v="51"/>
          <ac:cxnSpMkLst>
            <pc:docMk/>
            <pc:sldMk cId="674739061" sldId="257"/>
            <ac:cxnSpMk id="12" creationId="{C0F713D2-1EFC-4D19-BBE6-7F9B2B54CAB7}"/>
          </ac:cxnSpMkLst>
        </pc:cxnChg>
        <pc:cxnChg chg="mod">
          <ac:chgData name="Derei Wu" userId="935b1b74ff2f2987" providerId="LiveId" clId="{1854D986-F87E-40F0-A096-6F3B6D2CC249}" dt="2021-08-16T12:09:35.357" v="51"/>
          <ac:cxnSpMkLst>
            <pc:docMk/>
            <pc:sldMk cId="674739061" sldId="257"/>
            <ac:cxnSpMk id="13" creationId="{F4AC1DD3-A802-4C2C-892F-E6E528F8A8DE}"/>
          </ac:cxnSpMkLst>
        </pc:cxnChg>
      </pc:sldChg>
    </pc:docChg>
  </pc:docChgLst>
  <pc:docChgLst>
    <pc:chgData name="Derei Wu" userId="935b1b74ff2f2987" providerId="LiveId" clId="{9D34867A-E9F1-4E05-9967-BE28F4A3F2EB}"/>
    <pc:docChg chg="modSld">
      <pc:chgData name="Derei Wu" userId="935b1b74ff2f2987" providerId="LiveId" clId="{9D34867A-E9F1-4E05-9967-BE28F4A3F2EB}" dt="2021-08-11T06:58:07.557" v="21"/>
      <pc:docMkLst>
        <pc:docMk/>
      </pc:docMkLst>
      <pc:sldChg chg="modSp mod">
        <pc:chgData name="Derei Wu" userId="935b1b74ff2f2987" providerId="LiveId" clId="{9D34867A-E9F1-4E05-9967-BE28F4A3F2EB}" dt="2021-08-11T06:58:07.557" v="21"/>
        <pc:sldMkLst>
          <pc:docMk/>
          <pc:sldMk cId="799743445" sldId="256"/>
        </pc:sldMkLst>
        <pc:spChg chg="mod">
          <ac:chgData name="Derei Wu" userId="935b1b74ff2f2987" providerId="LiveId" clId="{9D34867A-E9F1-4E05-9967-BE28F4A3F2EB}" dt="2021-08-11T06:57:02.431" v="0" actId="403"/>
          <ac:spMkLst>
            <pc:docMk/>
            <pc:sldMk cId="799743445" sldId="256"/>
            <ac:spMk id="6" creationId="{AA209B12-63A1-46C4-8C5B-76F02F84E309}"/>
          </ac:spMkLst>
        </pc:spChg>
        <pc:graphicFrameChg chg="mod">
          <ac:chgData name="Derei Wu" userId="935b1b74ff2f2987" providerId="LiveId" clId="{9D34867A-E9F1-4E05-9967-BE28F4A3F2EB}" dt="2021-08-11T06:57:19.974" v="18" actId="1038"/>
          <ac:graphicFrameMkLst>
            <pc:docMk/>
            <pc:sldMk cId="799743445" sldId="256"/>
            <ac:graphicFrameMk id="2" creationId="{54E531A8-7362-4217-AF5D-3D219B62B713}"/>
          </ac:graphicFrameMkLst>
        </pc:graphicFrameChg>
        <pc:graphicFrameChg chg="mod">
          <ac:chgData name="Derei Wu" userId="935b1b74ff2f2987" providerId="LiveId" clId="{9D34867A-E9F1-4E05-9967-BE28F4A3F2EB}" dt="2021-08-11T06:58:07.557" v="21"/>
          <ac:graphicFrameMkLst>
            <pc:docMk/>
            <pc:sldMk cId="799743445" sldId="256"/>
            <ac:graphicFrameMk id="3" creationId="{DC5639D3-BC4D-4D43-A0E6-E76F1D0A0238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1346836"/>
            <a:ext cx="10287000" cy="2865120"/>
          </a:xfrm>
        </p:spPr>
        <p:txBody>
          <a:bodyPr anchor="b"/>
          <a:lstStyle>
            <a:lvl1pPr algn="ctr">
              <a:defRPr sz="67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4322446"/>
            <a:ext cx="10287000" cy="1986914"/>
          </a:xfrm>
        </p:spPr>
        <p:txBody>
          <a:bodyPr/>
          <a:lstStyle>
            <a:lvl1pPr marL="0" indent="0" algn="ctr">
              <a:buNone/>
              <a:defRPr sz="2700"/>
            </a:lvl1pPr>
            <a:lvl2pPr marL="514350" indent="0" algn="ctr">
              <a:buNone/>
              <a:defRPr sz="2250"/>
            </a:lvl2pPr>
            <a:lvl3pPr marL="1028700" indent="0" algn="ctr">
              <a:buNone/>
              <a:defRPr sz="2025"/>
            </a:lvl3pPr>
            <a:lvl4pPr marL="1543050" indent="0" algn="ctr">
              <a:buNone/>
              <a:defRPr sz="1800"/>
            </a:lvl4pPr>
            <a:lvl5pPr marL="2057400" indent="0" algn="ctr">
              <a:buNone/>
              <a:defRPr sz="1800"/>
            </a:lvl5pPr>
            <a:lvl6pPr marL="2571750" indent="0" algn="ctr">
              <a:buNone/>
              <a:defRPr sz="1800"/>
            </a:lvl6pPr>
            <a:lvl7pPr marL="3086100" indent="0" algn="ctr">
              <a:buNone/>
              <a:defRPr sz="1800"/>
            </a:lvl7pPr>
            <a:lvl8pPr marL="3600450" indent="0" algn="ctr">
              <a:buNone/>
              <a:defRPr sz="1800"/>
            </a:lvl8pPr>
            <a:lvl9pPr marL="4114800" indent="0" algn="ctr">
              <a:buNone/>
              <a:defRPr sz="1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0076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2604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2" y="438150"/>
            <a:ext cx="295751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5" y="438150"/>
            <a:ext cx="870108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6515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303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1" y="2051686"/>
            <a:ext cx="11830050" cy="3423284"/>
          </a:xfrm>
        </p:spPr>
        <p:txBody>
          <a:bodyPr anchor="b"/>
          <a:lstStyle>
            <a:lvl1pPr>
              <a:defRPr sz="67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1" y="5507356"/>
            <a:ext cx="11830050" cy="1800224"/>
          </a:xfrm>
        </p:spPr>
        <p:txBody>
          <a:bodyPr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514350" indent="0">
              <a:buNone/>
              <a:defRPr sz="2250">
                <a:solidFill>
                  <a:schemeClr val="tx1">
                    <a:tint val="75000"/>
                  </a:schemeClr>
                </a:solidFill>
              </a:defRPr>
            </a:lvl2pPr>
            <a:lvl3pPr marL="1028700" indent="0">
              <a:buNone/>
              <a:defRPr sz="2025">
                <a:solidFill>
                  <a:schemeClr val="tx1">
                    <a:tint val="75000"/>
                  </a:schemeClr>
                </a:solidFill>
              </a:defRPr>
            </a:lvl3pPr>
            <a:lvl4pPr marL="154305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057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57175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0861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360045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1148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998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2190750"/>
            <a:ext cx="58293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2190750"/>
            <a:ext cx="58293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0296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38150"/>
            <a:ext cx="1183005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2" y="2017396"/>
            <a:ext cx="5802510" cy="98869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350" indent="0">
              <a:buNone/>
              <a:defRPr sz="2250" b="1"/>
            </a:lvl2pPr>
            <a:lvl3pPr marL="1028700" indent="0">
              <a:buNone/>
              <a:defRPr sz="2025" b="1"/>
            </a:lvl3pPr>
            <a:lvl4pPr marL="1543050" indent="0">
              <a:buNone/>
              <a:defRPr sz="1800" b="1"/>
            </a:lvl4pPr>
            <a:lvl5pPr marL="2057400" indent="0">
              <a:buNone/>
              <a:defRPr sz="1800" b="1"/>
            </a:lvl5pPr>
            <a:lvl6pPr marL="2571750" indent="0">
              <a:buNone/>
              <a:defRPr sz="1800" b="1"/>
            </a:lvl6pPr>
            <a:lvl7pPr marL="3086100" indent="0">
              <a:buNone/>
              <a:defRPr sz="1800" b="1"/>
            </a:lvl7pPr>
            <a:lvl8pPr marL="3600450" indent="0">
              <a:buNone/>
              <a:defRPr sz="1800" b="1"/>
            </a:lvl8pPr>
            <a:lvl9pPr marL="4114800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2" y="3006090"/>
            <a:ext cx="5802510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5" y="2017396"/>
            <a:ext cx="5831087" cy="98869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350" indent="0">
              <a:buNone/>
              <a:defRPr sz="2250" b="1"/>
            </a:lvl2pPr>
            <a:lvl3pPr marL="1028700" indent="0">
              <a:buNone/>
              <a:defRPr sz="2025" b="1"/>
            </a:lvl3pPr>
            <a:lvl4pPr marL="1543050" indent="0">
              <a:buNone/>
              <a:defRPr sz="1800" b="1"/>
            </a:lvl4pPr>
            <a:lvl5pPr marL="2057400" indent="0">
              <a:buNone/>
              <a:defRPr sz="1800" b="1"/>
            </a:lvl5pPr>
            <a:lvl6pPr marL="2571750" indent="0">
              <a:buNone/>
              <a:defRPr sz="1800" b="1"/>
            </a:lvl6pPr>
            <a:lvl7pPr marL="3086100" indent="0">
              <a:buNone/>
              <a:defRPr sz="1800" b="1"/>
            </a:lvl7pPr>
            <a:lvl8pPr marL="3600450" indent="0">
              <a:buNone/>
              <a:defRPr sz="1800" b="1"/>
            </a:lvl8pPr>
            <a:lvl9pPr marL="4114800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5" y="3006090"/>
            <a:ext cx="5831087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173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2158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788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548640"/>
            <a:ext cx="4423767" cy="1920240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184911"/>
            <a:ext cx="6943725" cy="5848350"/>
          </a:xfrm>
        </p:spPr>
        <p:txBody>
          <a:bodyPr/>
          <a:lstStyle>
            <a:lvl1pPr>
              <a:defRPr sz="3600"/>
            </a:lvl1pPr>
            <a:lvl2pPr>
              <a:defRPr sz="3150"/>
            </a:lvl2pPr>
            <a:lvl3pPr>
              <a:defRPr sz="2700"/>
            </a:lvl3pPr>
            <a:lvl4pPr>
              <a:defRPr sz="2250"/>
            </a:lvl4pPr>
            <a:lvl5pPr>
              <a:defRPr sz="2250"/>
            </a:lvl5pPr>
            <a:lvl6pPr>
              <a:defRPr sz="2250"/>
            </a:lvl6pPr>
            <a:lvl7pPr>
              <a:defRPr sz="2250"/>
            </a:lvl7pPr>
            <a:lvl8pPr>
              <a:defRPr sz="2250"/>
            </a:lvl8pPr>
            <a:lvl9pPr>
              <a:defRPr sz="22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2468880"/>
            <a:ext cx="4423767" cy="4573906"/>
          </a:xfrm>
        </p:spPr>
        <p:txBody>
          <a:bodyPr/>
          <a:lstStyle>
            <a:lvl1pPr marL="0" indent="0">
              <a:buNone/>
              <a:defRPr sz="1800"/>
            </a:lvl1pPr>
            <a:lvl2pPr marL="514350" indent="0">
              <a:buNone/>
              <a:defRPr sz="1575"/>
            </a:lvl2pPr>
            <a:lvl3pPr marL="1028700" indent="0">
              <a:buNone/>
              <a:defRPr sz="1350"/>
            </a:lvl3pPr>
            <a:lvl4pPr marL="1543050" indent="0">
              <a:buNone/>
              <a:defRPr sz="1125"/>
            </a:lvl4pPr>
            <a:lvl5pPr marL="2057400" indent="0">
              <a:buNone/>
              <a:defRPr sz="1125"/>
            </a:lvl5pPr>
            <a:lvl6pPr marL="2571750" indent="0">
              <a:buNone/>
              <a:defRPr sz="1125"/>
            </a:lvl6pPr>
            <a:lvl7pPr marL="3086100" indent="0">
              <a:buNone/>
              <a:defRPr sz="1125"/>
            </a:lvl7pPr>
            <a:lvl8pPr marL="3600450" indent="0">
              <a:buNone/>
              <a:defRPr sz="1125"/>
            </a:lvl8pPr>
            <a:lvl9pPr marL="4114800" indent="0">
              <a:buNone/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5776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548640"/>
            <a:ext cx="4423767" cy="1920240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184911"/>
            <a:ext cx="6943725" cy="5848350"/>
          </a:xfrm>
        </p:spPr>
        <p:txBody>
          <a:bodyPr anchor="t"/>
          <a:lstStyle>
            <a:lvl1pPr marL="0" indent="0">
              <a:buNone/>
              <a:defRPr sz="3600"/>
            </a:lvl1pPr>
            <a:lvl2pPr marL="514350" indent="0">
              <a:buNone/>
              <a:defRPr sz="3150"/>
            </a:lvl2pPr>
            <a:lvl3pPr marL="1028700" indent="0">
              <a:buNone/>
              <a:defRPr sz="2700"/>
            </a:lvl3pPr>
            <a:lvl4pPr marL="1543050" indent="0">
              <a:buNone/>
              <a:defRPr sz="2250"/>
            </a:lvl4pPr>
            <a:lvl5pPr marL="2057400" indent="0">
              <a:buNone/>
              <a:defRPr sz="2250"/>
            </a:lvl5pPr>
            <a:lvl6pPr marL="2571750" indent="0">
              <a:buNone/>
              <a:defRPr sz="2250"/>
            </a:lvl6pPr>
            <a:lvl7pPr marL="3086100" indent="0">
              <a:buNone/>
              <a:defRPr sz="2250"/>
            </a:lvl7pPr>
            <a:lvl8pPr marL="3600450" indent="0">
              <a:buNone/>
              <a:defRPr sz="2250"/>
            </a:lvl8pPr>
            <a:lvl9pPr marL="4114800" indent="0">
              <a:buNone/>
              <a:defRPr sz="22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2468880"/>
            <a:ext cx="4423767" cy="4573906"/>
          </a:xfrm>
        </p:spPr>
        <p:txBody>
          <a:bodyPr/>
          <a:lstStyle>
            <a:lvl1pPr marL="0" indent="0">
              <a:buNone/>
              <a:defRPr sz="1800"/>
            </a:lvl1pPr>
            <a:lvl2pPr marL="514350" indent="0">
              <a:buNone/>
              <a:defRPr sz="1575"/>
            </a:lvl2pPr>
            <a:lvl3pPr marL="1028700" indent="0">
              <a:buNone/>
              <a:defRPr sz="1350"/>
            </a:lvl3pPr>
            <a:lvl4pPr marL="1543050" indent="0">
              <a:buNone/>
              <a:defRPr sz="1125"/>
            </a:lvl4pPr>
            <a:lvl5pPr marL="2057400" indent="0">
              <a:buNone/>
              <a:defRPr sz="1125"/>
            </a:lvl5pPr>
            <a:lvl6pPr marL="2571750" indent="0">
              <a:buNone/>
              <a:defRPr sz="1125"/>
            </a:lvl6pPr>
            <a:lvl7pPr marL="3086100" indent="0">
              <a:buNone/>
              <a:defRPr sz="1125"/>
            </a:lvl7pPr>
            <a:lvl8pPr marL="3600450" indent="0">
              <a:buNone/>
              <a:defRPr sz="1125"/>
            </a:lvl8pPr>
            <a:lvl9pPr marL="4114800" indent="0">
              <a:buNone/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371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438150"/>
            <a:ext cx="1183005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2190750"/>
            <a:ext cx="1183005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7627621"/>
            <a:ext cx="30861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C1AEB-8673-4A8E-9B5F-D49B20E26F2D}" type="datetimeFigureOut">
              <a:rPr lang="zh-CN" altLang="en-US" smtClean="0"/>
              <a:t>2022/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7627621"/>
            <a:ext cx="46291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7627621"/>
            <a:ext cx="30861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2C4B7-81D2-46C2-A60B-2EB513108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693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28700" rtl="0" eaLnBrk="1" latinLnBrk="0" hangingPunct="1">
        <a:lnSpc>
          <a:spcPct val="90000"/>
        </a:lnSpc>
        <a:spcBef>
          <a:spcPct val="0"/>
        </a:spcBef>
        <a:buNone/>
        <a:defRPr sz="49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10287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1pPr>
      <a:lvl2pPr marL="77152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28587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3pPr>
      <a:lvl4pPr marL="180022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4pPr>
      <a:lvl5pPr marL="231457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5pPr>
      <a:lvl6pPr marL="282892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6pPr>
      <a:lvl7pPr marL="334327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7pPr>
      <a:lvl8pPr marL="385762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8pPr>
      <a:lvl9pPr marL="4371975" indent="-257175" algn="l" defTabSz="102870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3pPr>
      <a:lvl4pPr marL="154305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5pPr>
      <a:lvl6pPr marL="257175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6pPr>
      <a:lvl7pPr marL="308610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8pPr>
      <a:lvl9pPr marL="4114800" algn="l" defTabSz="1028700" rtl="0" eaLnBrk="1" latinLnBrk="0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54E531A8-7362-4217-AF5D-3D219B62B7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6776286"/>
              </p:ext>
            </p:extLst>
          </p:nvPr>
        </p:nvGraphicFramePr>
        <p:xfrm>
          <a:off x="699608" y="1060451"/>
          <a:ext cx="3862387" cy="3490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9" r:id="rId3" imgW="3861735" imgH="3490297" progId="Prism9.Document">
                  <p:embed/>
                </p:oleObj>
              </mc:Choice>
              <mc:Fallback>
                <p:oleObj name="Prism 9" r:id="rId3" imgW="3861735" imgH="3490297" progId="Prism9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54E531A8-7362-4217-AF5D-3D219B62B7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9608" y="1060451"/>
                        <a:ext cx="3862387" cy="3490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DC5639D3-BC4D-4D43-A0E6-E76F1D0A02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2217232"/>
              </p:ext>
            </p:extLst>
          </p:nvPr>
        </p:nvGraphicFramePr>
        <p:xfrm>
          <a:off x="4516439" y="1190625"/>
          <a:ext cx="2854325" cy="335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9" r:id="rId5" imgW="2853718" imgH="3352621" progId="Prism9.Document">
                  <p:embed/>
                </p:oleObj>
              </mc:Choice>
              <mc:Fallback>
                <p:oleObj name="Prism 9" r:id="rId5" imgW="2853718" imgH="3352621" progId="Prism9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DC5639D3-BC4D-4D43-A0E6-E76F1D0A02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16439" y="1190625"/>
                        <a:ext cx="2854325" cy="335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921EF72C-A428-44BB-855E-0734D63BFF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0649127"/>
              </p:ext>
            </p:extLst>
          </p:nvPr>
        </p:nvGraphicFramePr>
        <p:xfrm>
          <a:off x="7203453" y="1277938"/>
          <a:ext cx="2936875" cy="3055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9" r:id="rId7" imgW="2936186" imgH="3056080" progId="Prism9.Document">
                  <p:embed/>
                </p:oleObj>
              </mc:Choice>
              <mc:Fallback>
                <p:oleObj name="Prism 9" r:id="rId7" imgW="2936186" imgH="3056080" progId="Prism9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921EF72C-A428-44BB-855E-0734D63BFF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203453" y="1277938"/>
                        <a:ext cx="2936875" cy="3055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E45C4B84-6D4A-4E5A-8486-88D4949590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6883694"/>
              </p:ext>
            </p:extLst>
          </p:nvPr>
        </p:nvGraphicFramePr>
        <p:xfrm>
          <a:off x="10017126" y="1277937"/>
          <a:ext cx="2936875" cy="3055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9" r:id="rId9" imgW="2936186" imgH="3056080" progId="Prism9.Document">
                  <p:embed/>
                </p:oleObj>
              </mc:Choice>
              <mc:Fallback>
                <p:oleObj name="Prism 9" r:id="rId9" imgW="2936186" imgH="3056080" progId="Prism9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E45C4B84-6D4A-4E5A-8486-88D4949590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0017126" y="1277937"/>
                        <a:ext cx="2936875" cy="3055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A209B12-63A1-46C4-8C5B-76F02F84E309}"/>
              </a:ext>
            </a:extLst>
          </p:cNvPr>
          <p:cNvSpPr txBox="1"/>
          <p:nvPr/>
        </p:nvSpPr>
        <p:spPr>
          <a:xfrm>
            <a:off x="1047750" y="4800601"/>
            <a:ext cx="1152525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kern="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We analyzed the proportion of </a:t>
            </a:r>
            <a:r>
              <a:rPr lang="en-US" sz="2000" kern="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γδT</a:t>
            </a:r>
            <a:r>
              <a:rPr lang="en-US" sz="2000" kern="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cells in paired PBMCs, liver perfusate and liver tissue from 12 patients. The results showed less </a:t>
            </a:r>
            <a:r>
              <a:rPr lang="en-US" sz="2000" kern="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γδT</a:t>
            </a:r>
            <a:r>
              <a:rPr lang="en-US" sz="2000" kern="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in the PBMCs than in the liver, for the proportion of </a:t>
            </a:r>
            <a:r>
              <a:rPr lang="en-US" sz="2000" kern="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γδT</a:t>
            </a:r>
            <a:r>
              <a:rPr lang="en-US" sz="2000" kern="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in PBMC was lower than in the liver perfusate and liver tissue (P =0.0063, P =0.0013, respectively). Meanwhile, there was no difference in the ratio of </a:t>
            </a:r>
            <a:r>
              <a:rPr lang="en-US" sz="2000" kern="0" dirty="0" err="1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γδT</a:t>
            </a:r>
            <a:r>
              <a:rPr lang="en-US" sz="2000" kern="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between liver tissue and perfusate. The following </a:t>
            </a:r>
            <a:r>
              <a:rPr lang="en-US" sz="20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estimation plots provided a visual means of interpreting results, </a:t>
            </a:r>
            <a:r>
              <a:rPr lang="en-US" sz="2000" kern="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onsidering that the 95%-CI of differences between liver perfusate and PBMC, liver tissue and PBMC were 1.730-8.249 and 2.504-7.857, while 95%CI of differences between liver tissue and perfusate was 1.009-1.392, this further suggested that liver perfusate can be a representative of liver.</a:t>
            </a:r>
            <a:endParaRPr lang="en-US" sz="20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D3DDD0-91FB-4725-BA48-AD18FA278332}"/>
              </a:ext>
            </a:extLst>
          </p:cNvPr>
          <p:cNvSpPr txBox="1"/>
          <p:nvPr/>
        </p:nvSpPr>
        <p:spPr>
          <a:xfrm>
            <a:off x="202652" y="273189"/>
            <a:ext cx="628248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upporting</a:t>
            </a:r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aterial</a:t>
            </a:r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_S1A</a:t>
            </a:r>
          </a:p>
        </p:txBody>
      </p:sp>
    </p:spTree>
    <p:extLst>
      <p:ext uri="{BB962C8B-B14F-4D97-AF65-F5344CB8AC3E}">
        <p14:creationId xmlns:p14="http://schemas.microsoft.com/office/powerpoint/2010/main" val="7997434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84F7B0A-5B13-473C-A9A4-FBF27C1858B6}"/>
              </a:ext>
            </a:extLst>
          </p:cNvPr>
          <p:cNvSpPr txBox="1"/>
          <p:nvPr/>
        </p:nvSpPr>
        <p:spPr>
          <a:xfrm>
            <a:off x="339217" y="328419"/>
            <a:ext cx="880306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>
                <a:latin typeface="Arial" panose="020B0604020202020204" pitchFamily="34" charset="0"/>
                <a:cs typeface="Arial" panose="020B0604020202020204" pitchFamily="34" charset="0"/>
              </a:rPr>
              <a:t>Supporting </a:t>
            </a:r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Material_S1</a:t>
            </a:r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组合 13">
            <a:extLst>
              <a:ext uri="{FF2B5EF4-FFF2-40B4-BE49-F238E27FC236}">
                <a16:creationId xmlns:a16="http://schemas.microsoft.com/office/drawing/2014/main" id="{4B0E5D08-9508-472D-849D-513A9DE39882}"/>
              </a:ext>
            </a:extLst>
          </p:cNvPr>
          <p:cNvGrpSpPr>
            <a:grpSpLocks noChangeAspect="1"/>
          </p:cNvGrpSpPr>
          <p:nvPr/>
        </p:nvGrpSpPr>
        <p:grpSpPr>
          <a:xfrm>
            <a:off x="8846530" y="1166964"/>
            <a:ext cx="4480996" cy="6548863"/>
            <a:chOff x="4892296" y="2524340"/>
            <a:chExt cx="6281698" cy="9180543"/>
          </a:xfrm>
        </p:grpSpPr>
        <p:grpSp>
          <p:nvGrpSpPr>
            <p:cNvPr id="4" name="组合 16">
              <a:extLst>
                <a:ext uri="{FF2B5EF4-FFF2-40B4-BE49-F238E27FC236}">
                  <a16:creationId xmlns:a16="http://schemas.microsoft.com/office/drawing/2014/main" id="{2D35CF4B-8D1C-4293-8954-3F44F1E62B86}"/>
                </a:ext>
              </a:extLst>
            </p:cNvPr>
            <p:cNvGrpSpPr/>
            <p:nvPr/>
          </p:nvGrpSpPr>
          <p:grpSpPr>
            <a:xfrm>
              <a:off x="4892296" y="3048090"/>
              <a:ext cx="6281698" cy="8656793"/>
              <a:chOff x="4388272" y="4266129"/>
              <a:chExt cx="6281698" cy="8656793"/>
            </a:xfrm>
          </p:grpSpPr>
          <p:grpSp>
            <p:nvGrpSpPr>
              <p:cNvPr id="9" name="组合 14">
                <a:extLst>
                  <a:ext uri="{FF2B5EF4-FFF2-40B4-BE49-F238E27FC236}">
                    <a16:creationId xmlns:a16="http://schemas.microsoft.com/office/drawing/2014/main" id="{6C27F798-64B2-446D-871F-ACAF9A5F5079}"/>
                  </a:ext>
                </a:extLst>
              </p:cNvPr>
              <p:cNvGrpSpPr/>
              <p:nvPr/>
            </p:nvGrpSpPr>
            <p:grpSpPr>
              <a:xfrm>
                <a:off x="4756391" y="5977457"/>
                <a:ext cx="5913579" cy="6945465"/>
                <a:chOff x="4984756" y="5977457"/>
                <a:chExt cx="5913579" cy="6945465"/>
              </a:xfrm>
            </p:grpSpPr>
            <p:grpSp>
              <p:nvGrpSpPr>
                <p:cNvPr id="11" name="组合 10">
                  <a:extLst>
                    <a:ext uri="{FF2B5EF4-FFF2-40B4-BE49-F238E27FC236}">
                      <a16:creationId xmlns:a16="http://schemas.microsoft.com/office/drawing/2014/main" id="{D5A226A3-3061-41BA-B673-10A88C32CF53}"/>
                    </a:ext>
                  </a:extLst>
                </p:cNvPr>
                <p:cNvGrpSpPr/>
                <p:nvPr/>
              </p:nvGrpSpPr>
              <p:grpSpPr>
                <a:xfrm>
                  <a:off x="4984756" y="12346028"/>
                  <a:ext cx="5913579" cy="576894"/>
                  <a:chOff x="4984756" y="12346028"/>
                  <a:chExt cx="5913579" cy="576894"/>
                </a:xfrm>
              </p:grpSpPr>
              <p:cxnSp>
                <p:nvCxnSpPr>
                  <p:cNvPr id="13" name="直接箭头连接符 8">
                    <a:extLst>
                      <a:ext uri="{FF2B5EF4-FFF2-40B4-BE49-F238E27FC236}">
                        <a16:creationId xmlns:a16="http://schemas.microsoft.com/office/drawing/2014/main" id="{F4AC1DD3-A802-4C2C-892F-E6E528F8A8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84756" y="12530694"/>
                    <a:ext cx="4885449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" name="文本框 9">
                    <a:extLst>
                      <a:ext uri="{FF2B5EF4-FFF2-40B4-BE49-F238E27FC236}">
                        <a16:creationId xmlns:a16="http://schemas.microsoft.com/office/drawing/2014/main" id="{CEF0DC3C-A642-4C1B-9011-2338B9107673}"/>
                      </a:ext>
                    </a:extLst>
                  </p:cNvPr>
                  <p:cNvSpPr txBox="1"/>
                  <p:nvPr/>
                </p:nvSpPr>
                <p:spPr>
                  <a:xfrm>
                    <a:off x="9956319" y="12346028"/>
                    <a:ext cx="942016" cy="57689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dirty="0"/>
                      <a:t>CD3</a:t>
                    </a:r>
                    <a:endParaRPr lang="zh-CN" altLang="en-US" dirty="0"/>
                  </a:p>
                </p:txBody>
              </p:sp>
            </p:grpSp>
            <p:cxnSp>
              <p:nvCxnSpPr>
                <p:cNvPr id="12" name="直接箭头连接符 11">
                  <a:extLst>
                    <a:ext uri="{FF2B5EF4-FFF2-40B4-BE49-F238E27FC236}">
                      <a16:creationId xmlns:a16="http://schemas.microsoft.com/office/drawing/2014/main" id="{C0F713D2-1EFC-4D19-BBE6-7F9B2B54CA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984756" y="5977457"/>
                  <a:ext cx="0" cy="6560671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文本框 15">
                <a:extLst>
                  <a:ext uri="{FF2B5EF4-FFF2-40B4-BE49-F238E27FC236}">
                    <a16:creationId xmlns:a16="http://schemas.microsoft.com/office/drawing/2014/main" id="{8BA492B9-9661-4747-8163-B5013DC29AD5}"/>
                  </a:ext>
                </a:extLst>
              </p:cNvPr>
              <p:cNvSpPr txBox="1"/>
              <p:nvPr/>
            </p:nvSpPr>
            <p:spPr>
              <a:xfrm rot="10800000">
                <a:off x="4388272" y="4266129"/>
                <a:ext cx="706332" cy="127774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dirty="0" err="1">
                    <a:ea typeface="宋体" panose="02010600030101010101" pitchFamily="2" charset="-122"/>
                    <a:cs typeface="Times New Roman" panose="02020603050405020304" pitchFamily="18" charset="0"/>
                  </a:rPr>
                  <a:t>γδ</a:t>
                </a:r>
                <a:r>
                  <a:rPr lang="en-US" altLang="zh-CN" dirty="0">
                    <a:ea typeface="宋体" panose="02010600030101010101" pitchFamily="2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dirty="0">
                    <a:ea typeface="宋体" panose="02010600030101010101" pitchFamily="2" charset="-122"/>
                    <a:cs typeface="Calibri" panose="020F0502020204030204" pitchFamily="34" charset="0"/>
                  </a:rPr>
                  <a:t>TCR</a:t>
                </a:r>
                <a:endParaRPr lang="zh-CN" altLang="en-US" dirty="0"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pic>
          <p:nvPicPr>
            <p:cNvPr id="5" name="图片 2" descr="散点图&#10;&#10;描述已自动生成">
              <a:extLst>
                <a:ext uri="{FF2B5EF4-FFF2-40B4-BE49-F238E27FC236}">
                  <a16:creationId xmlns:a16="http://schemas.microsoft.com/office/drawing/2014/main" id="{535D92E2-F139-4115-82BA-DF814A3BF1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13724" y="2909208"/>
              <a:ext cx="2838450" cy="8305800"/>
            </a:xfrm>
            <a:prstGeom prst="rect">
              <a:avLst/>
            </a:prstGeom>
          </p:spPr>
        </p:pic>
        <p:pic>
          <p:nvPicPr>
            <p:cNvPr id="6" name="图片 6" descr="图表, 散点图&#10;&#10;描述已自动生成">
              <a:extLst>
                <a:ext uri="{FF2B5EF4-FFF2-40B4-BE49-F238E27FC236}">
                  <a16:creationId xmlns:a16="http://schemas.microsoft.com/office/drawing/2014/main" id="{9595D81C-536E-4217-AF04-30898D493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48761" y="2893306"/>
              <a:ext cx="2828925" cy="8315325"/>
            </a:xfrm>
            <a:prstGeom prst="rect">
              <a:avLst/>
            </a:prstGeom>
          </p:spPr>
        </p:pic>
        <p:sp>
          <p:nvSpPr>
            <p:cNvPr id="7" name="文本框 12">
              <a:extLst>
                <a:ext uri="{FF2B5EF4-FFF2-40B4-BE49-F238E27FC236}">
                  <a16:creationId xmlns:a16="http://schemas.microsoft.com/office/drawing/2014/main" id="{EFE1A6CD-AC37-4E8E-8B6B-8089C286C0CB}"/>
                </a:ext>
              </a:extLst>
            </p:cNvPr>
            <p:cNvSpPr txBox="1"/>
            <p:nvPr/>
          </p:nvSpPr>
          <p:spPr>
            <a:xfrm>
              <a:off x="6432882" y="2524340"/>
              <a:ext cx="1454371" cy="5768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Patient</a:t>
              </a:r>
              <a:endParaRPr lang="zh-CN" altLang="en-US" b="1" dirty="0"/>
            </a:p>
          </p:txBody>
        </p:sp>
        <p:sp>
          <p:nvSpPr>
            <p:cNvPr id="8" name="文本框 30">
              <a:extLst>
                <a:ext uri="{FF2B5EF4-FFF2-40B4-BE49-F238E27FC236}">
                  <a16:creationId xmlns:a16="http://schemas.microsoft.com/office/drawing/2014/main" id="{414FB12F-5EAA-4A30-8F60-60500904506C}"/>
                </a:ext>
              </a:extLst>
            </p:cNvPr>
            <p:cNvSpPr txBox="1"/>
            <p:nvPr/>
          </p:nvSpPr>
          <p:spPr>
            <a:xfrm>
              <a:off x="9314188" y="2524340"/>
              <a:ext cx="1521787" cy="5768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/>
                <a:t>Control</a:t>
              </a:r>
              <a:endParaRPr lang="zh-CN" altLang="en-US" b="1" dirty="0"/>
            </a:p>
          </p:txBody>
        </p:sp>
      </p:grp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0F322639-1430-4C86-8232-A3B2E76C8E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0373357"/>
              </p:ext>
            </p:extLst>
          </p:nvPr>
        </p:nvGraphicFramePr>
        <p:xfrm>
          <a:off x="390524" y="1938328"/>
          <a:ext cx="8381995" cy="554355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52795">
                  <a:extLst>
                    <a:ext uri="{9D8B030D-6E8A-4147-A177-3AD203B41FA5}">
                      <a16:colId xmlns:a16="http://schemas.microsoft.com/office/drawing/2014/main" val="644319891"/>
                    </a:ext>
                  </a:extLst>
                </a:gridCol>
                <a:gridCol w="1246785">
                  <a:extLst>
                    <a:ext uri="{9D8B030D-6E8A-4147-A177-3AD203B41FA5}">
                      <a16:colId xmlns:a16="http://schemas.microsoft.com/office/drawing/2014/main" val="842571194"/>
                    </a:ext>
                  </a:extLst>
                </a:gridCol>
                <a:gridCol w="1036483">
                  <a:extLst>
                    <a:ext uri="{9D8B030D-6E8A-4147-A177-3AD203B41FA5}">
                      <a16:colId xmlns:a16="http://schemas.microsoft.com/office/drawing/2014/main" val="2947608881"/>
                    </a:ext>
                  </a:extLst>
                </a:gridCol>
                <a:gridCol w="1036483">
                  <a:extLst>
                    <a:ext uri="{9D8B030D-6E8A-4147-A177-3AD203B41FA5}">
                      <a16:colId xmlns:a16="http://schemas.microsoft.com/office/drawing/2014/main" val="2431375645"/>
                    </a:ext>
                  </a:extLst>
                </a:gridCol>
                <a:gridCol w="1036483">
                  <a:extLst>
                    <a:ext uri="{9D8B030D-6E8A-4147-A177-3AD203B41FA5}">
                      <a16:colId xmlns:a16="http://schemas.microsoft.com/office/drawing/2014/main" val="2888445113"/>
                    </a:ext>
                  </a:extLst>
                </a:gridCol>
                <a:gridCol w="1036483">
                  <a:extLst>
                    <a:ext uri="{9D8B030D-6E8A-4147-A177-3AD203B41FA5}">
                      <a16:colId xmlns:a16="http://schemas.microsoft.com/office/drawing/2014/main" val="2936485161"/>
                    </a:ext>
                  </a:extLst>
                </a:gridCol>
                <a:gridCol w="1036483">
                  <a:extLst>
                    <a:ext uri="{9D8B030D-6E8A-4147-A177-3AD203B41FA5}">
                      <a16:colId xmlns:a16="http://schemas.microsoft.com/office/drawing/2014/main" val="3228021833"/>
                    </a:ext>
                  </a:extLst>
                </a:gridCol>
              </a:tblGrid>
              <a:tr h="280035">
                <a:tc>
                  <a:txBody>
                    <a:bodyPr/>
                    <a:lstStyle/>
                    <a:p>
                      <a:pPr algn="l" fontAlgn="ctr"/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1" u="none" strike="noStrike" dirty="0">
                          <a:effectLst/>
                        </a:rPr>
                        <a:t>Patient-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1" u="none" strike="noStrike" dirty="0">
                          <a:effectLst/>
                        </a:rPr>
                        <a:t>Patient-2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1" u="none" strike="noStrike">
                          <a:effectLst/>
                        </a:rPr>
                        <a:t>Patient-3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1" u="none" strike="noStrike" dirty="0">
                          <a:effectLst/>
                        </a:rPr>
                        <a:t>Control-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1" u="none" strike="noStrike" dirty="0">
                          <a:effectLst/>
                        </a:rPr>
                        <a:t>Control-2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1" u="none" strike="noStrike" dirty="0">
                          <a:effectLst/>
                        </a:rPr>
                        <a:t>Control-3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4161595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Gender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Mal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Mal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Mal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Femal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Femal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Mal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589731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Age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49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43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48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22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5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60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119416410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HIV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010190813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CMV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743930016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HBV-sAg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+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+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+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-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121456951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Creatinine( CREA) (</a:t>
                      </a:r>
                      <a:r>
                        <a:rPr lang="el-GR" sz="2000" b="1" u="none" strike="noStrike">
                          <a:effectLst/>
                        </a:rPr>
                        <a:t>μ</a:t>
                      </a:r>
                      <a:r>
                        <a:rPr lang="en-US" sz="2000" b="1" u="none" strike="noStrike">
                          <a:effectLst/>
                        </a:rPr>
                        <a:t>mol/L)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8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109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72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568403324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Prothrombin Time (PT)（s)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0.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12.2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11.1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543232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sv-SE" sz="2000" b="1" u="none" strike="noStrike">
                          <a:effectLst/>
                        </a:rPr>
                        <a:t>TBiL(Total Bilirubin) (μmol/L)</a:t>
                      </a:r>
                      <a:endParaRPr lang="sv-SE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88.8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36.7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12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215834205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ALB(Albumin) (g/L)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3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39.7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47.5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6262314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>
                          <a:effectLst/>
                        </a:rPr>
                        <a:t>Child-Pugh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33503523"/>
                  </a:ext>
                </a:extLst>
              </a:tr>
              <a:tr h="280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 err="1">
                          <a:effectLst/>
                        </a:rPr>
                        <a:t>TNM_stage</a:t>
                      </a:r>
                      <a:r>
                        <a:rPr lang="en-US" sz="2000" b="1" u="none" strike="noStrike" dirty="0">
                          <a:effectLst/>
                        </a:rPr>
                        <a:t> (ALTSG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Ⅲ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Ⅳ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Ⅲ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N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N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234345057"/>
                  </a:ext>
                </a:extLst>
              </a:tr>
            </a:tbl>
          </a:graphicData>
        </a:graphic>
      </p:graphicFrame>
      <p:sp>
        <p:nvSpPr>
          <p:cNvPr id="16" name="文本框 15">
            <a:extLst>
              <a:ext uri="{FF2B5EF4-FFF2-40B4-BE49-F238E27FC236}">
                <a16:creationId xmlns:a16="http://schemas.microsoft.com/office/drawing/2014/main" id="{1AA76642-0681-4DA4-AC86-42459FABA722}"/>
              </a:ext>
            </a:extLst>
          </p:cNvPr>
          <p:cNvSpPr txBox="1"/>
          <p:nvPr/>
        </p:nvSpPr>
        <p:spPr>
          <a:xfrm>
            <a:off x="13027327" y="2761338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b="1" dirty="0"/>
              <a:t>（</a:t>
            </a:r>
            <a:r>
              <a:rPr lang="en-US" altLang="zh-CN" b="1" dirty="0"/>
              <a:t>1</a:t>
            </a:r>
            <a:r>
              <a:rPr lang="zh-CN" altLang="en-US" b="1" dirty="0"/>
              <a:t>）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254FA9E-CBDE-413D-BFFC-D1960A8796D3}"/>
              </a:ext>
            </a:extLst>
          </p:cNvPr>
          <p:cNvSpPr txBox="1"/>
          <p:nvPr/>
        </p:nvSpPr>
        <p:spPr>
          <a:xfrm>
            <a:off x="13027326" y="6435846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b="1" dirty="0"/>
              <a:t>（</a:t>
            </a:r>
            <a:r>
              <a:rPr lang="en-US" altLang="zh-CN" b="1" dirty="0"/>
              <a:t>3</a:t>
            </a:r>
            <a:r>
              <a:rPr lang="zh-CN" altLang="en-US" b="1" dirty="0"/>
              <a:t>）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C50C1B3-23B0-48D0-B617-943BA4246E37}"/>
              </a:ext>
            </a:extLst>
          </p:cNvPr>
          <p:cNvSpPr txBox="1"/>
          <p:nvPr/>
        </p:nvSpPr>
        <p:spPr>
          <a:xfrm>
            <a:off x="13027327" y="4671450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b="1" dirty="0"/>
              <a:t>（</a:t>
            </a:r>
            <a:r>
              <a:rPr lang="en-US" altLang="zh-CN" b="1" dirty="0"/>
              <a:t>2</a:t>
            </a:r>
            <a:r>
              <a:rPr lang="zh-CN" altLang="en-US" b="1" dirty="0"/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674739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282</Words>
  <Application>Microsoft Office PowerPoint</Application>
  <PresentationFormat>自定义</PresentationFormat>
  <Paragraphs>93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DengXian</vt:lpstr>
      <vt:lpstr>Arial</vt:lpstr>
      <vt:lpstr>Calibri</vt:lpstr>
      <vt:lpstr>Calibri Light</vt:lpstr>
      <vt:lpstr>Office 主题​​</vt:lpstr>
      <vt:lpstr>Prism 9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何 文婧</dc:creator>
  <cp:lastModifiedBy>Derei Wu</cp:lastModifiedBy>
  <cp:revision>9</cp:revision>
  <dcterms:created xsi:type="dcterms:W3CDTF">2021-08-10T08:05:03Z</dcterms:created>
  <dcterms:modified xsi:type="dcterms:W3CDTF">2022-01-25T02:56:12Z</dcterms:modified>
</cp:coreProperties>
</file>